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98" d="100"/>
          <a:sy n="98" d="100"/>
        </p:scale>
        <p:origin x="64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37A567-1AC7-499B-B61F-2D6BE2A0087F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BCCD3E-EC09-4A17-9270-A743F13F0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680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BCCD3E-EC09-4A17-9270-A743F13F0E3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1213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755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7570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458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313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394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393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565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729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609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314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373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786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7707304"/>
              </p:ext>
            </p:extLst>
          </p:nvPr>
        </p:nvGraphicFramePr>
        <p:xfrm>
          <a:off x="572667" y="1422881"/>
          <a:ext cx="3471012" cy="17602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67753"/>
                <a:gridCol w="867753"/>
                <a:gridCol w="867753"/>
                <a:gridCol w="867753"/>
              </a:tblGrid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TR [</a:t>
                      </a:r>
                      <a:r>
                        <a:rPr lang="en-US" sz="1200" dirty="0" err="1" smtClean="0"/>
                        <a:t>ms</a:t>
                      </a:r>
                      <a:r>
                        <a:rPr lang="en-US" sz="1200" dirty="0" smtClean="0"/>
                        <a:t>]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 1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 2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</a:t>
                      </a:r>
                      <a:r>
                        <a:rPr lang="en-US" sz="1200" baseline="0" dirty="0" smtClean="0"/>
                        <a:t> 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2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62.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440.7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/>
                        <a:t>425.5</a:t>
                      </a:r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4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04.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723.4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/>
                        <a:t>682.0</a:t>
                      </a:r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28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955.2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.119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/>
                        <a:t>1.054e3</a:t>
                      </a:r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56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.433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.658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/>
                        <a:t>1.544e3</a:t>
                      </a:r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512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.040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.316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/>
                        <a:t>2.112e3</a:t>
                      </a:r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024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.697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.959e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/>
                        <a:t>2.647e3</a:t>
                      </a:r>
                    </a:p>
                  </a:txBody>
                  <a:tcPr marL="68580" marR="68580" marT="34290" marB="34290"/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49670" y="454357"/>
            <a:ext cx="77156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T1 data for spherical inclusion phantom, acquired on: </a:t>
            </a:r>
            <a:r>
              <a:rPr lang="en-US" sz="1600" b="1" dirty="0" smtClean="0"/>
              <a:t>2019-04-18</a:t>
            </a:r>
            <a:endParaRPr lang="en-US" sz="1600" b="1" dirty="0"/>
          </a:p>
        </p:txBody>
      </p:sp>
      <p:sp>
        <p:nvSpPr>
          <p:cNvPr id="9" name="Rectangle 8"/>
          <p:cNvSpPr/>
          <p:nvPr/>
        </p:nvSpPr>
        <p:spPr>
          <a:xfrm>
            <a:off x="4307494" y="1418347"/>
            <a:ext cx="4023706" cy="1277273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100" dirty="0" err="1">
                <a:solidFill>
                  <a:srgbClr val="000000"/>
                </a:solidFill>
                <a:latin typeface="Courier New" panose="02070309020205020404" pitchFamily="49" charset="0"/>
              </a:rPr>
              <a:t>modelfun</a:t>
            </a:r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=@(</a:t>
            </a:r>
            <a:r>
              <a:rPr lang="en-US" sz="1100" dirty="0" err="1">
                <a:solidFill>
                  <a:srgbClr val="000000"/>
                </a:solidFill>
                <a:latin typeface="Courier New" panose="02070309020205020404" pitchFamily="49" charset="0"/>
              </a:rPr>
              <a:t>p,x</a:t>
            </a:r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) p(1).*(1-exp(-x./p(2)))+p(3);</a:t>
            </a:r>
          </a:p>
          <a:p>
            <a:r>
              <a:rPr lang="en-US" sz="1100" dirty="0">
                <a:solidFill>
                  <a:srgbClr val="228B22"/>
                </a:solidFill>
                <a:latin typeface="Courier New" panose="02070309020205020404" pitchFamily="49" charset="0"/>
              </a:rPr>
              <a:t>%% for inclusion 1</a:t>
            </a:r>
          </a:p>
          <a:p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error=@(p) sum((mag_TR1-modelfun(</a:t>
            </a:r>
            <a:r>
              <a:rPr lang="en-US" sz="1100" dirty="0" err="1">
                <a:solidFill>
                  <a:srgbClr val="000000"/>
                </a:solidFill>
                <a:latin typeface="Courier New" panose="02070309020205020404" pitchFamily="49" charset="0"/>
              </a:rPr>
              <a:t>p,TR</a:t>
            </a:r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)).^2);</a:t>
            </a:r>
          </a:p>
          <a:p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P=</a:t>
            </a:r>
            <a:r>
              <a:rPr lang="en-US" sz="1100" dirty="0" err="1">
                <a:solidFill>
                  <a:srgbClr val="000000"/>
                </a:solidFill>
                <a:latin typeface="Courier New" panose="02070309020205020404" pitchFamily="49" charset="0"/>
              </a:rPr>
              <a:t>fminsearch</a:t>
            </a:r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(error,[2500 500 0]);</a:t>
            </a:r>
          </a:p>
          <a:p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M0_1=P(1);</a:t>
            </a:r>
          </a:p>
          <a:p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T1_1=P(2);</a:t>
            </a:r>
          </a:p>
          <a:p>
            <a:r>
              <a:rPr lang="en-US" sz="1100" dirty="0">
                <a:solidFill>
                  <a:srgbClr val="000000"/>
                </a:solidFill>
                <a:latin typeface="Courier New" panose="02070309020205020404" pitchFamily="49" charset="0"/>
              </a:rPr>
              <a:t>offset_1=P(3);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246537" y="1133671"/>
            <a:ext cx="20651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2) </a:t>
            </a:r>
            <a:r>
              <a:rPr lang="en-US" sz="1400" dirty="0" err="1" smtClean="0"/>
              <a:t>Matlab</a:t>
            </a:r>
            <a:r>
              <a:rPr lang="en-US" sz="1400" dirty="0" smtClean="0"/>
              <a:t> </a:t>
            </a:r>
            <a:r>
              <a:rPr lang="en-US" sz="1400" dirty="0"/>
              <a:t>code for fittin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90310" y="1133671"/>
            <a:ext cx="1591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1) Magnitude </a:t>
            </a:r>
            <a:r>
              <a:rPr lang="en-US" sz="1400" dirty="0"/>
              <a:t>dat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90310" y="3345965"/>
            <a:ext cx="1985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3) Results and T1 values</a:t>
            </a:r>
            <a:endParaRPr lang="en-US" sz="1400" dirty="0"/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0310" y="3642804"/>
            <a:ext cx="2673657" cy="2412000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70359" y="3654773"/>
            <a:ext cx="2673657" cy="2412000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80766" y="3653742"/>
            <a:ext cx="2674800" cy="2413031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112914" y="4045691"/>
            <a:ext cx="1601400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T1 for inclusion 1=441.41ms </a:t>
            </a:r>
            <a:endParaRPr lang="en-US" sz="105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890091" y="4045500"/>
            <a:ext cx="1570943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T1 for inclusion 2=392.49ms</a:t>
            </a:r>
            <a:endParaRPr lang="en-US" sz="105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6667490" y="4043406"/>
            <a:ext cx="1570943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T1 for inclusion 3=360.73ms</a:t>
            </a:r>
          </a:p>
        </p:txBody>
      </p:sp>
    </p:spTree>
    <p:extLst>
      <p:ext uri="{BB962C8B-B14F-4D97-AF65-F5344CB8AC3E}">
        <p14:creationId xmlns:p14="http://schemas.microsoft.com/office/powerpoint/2010/main" val="4223204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3139" y="3636750"/>
            <a:ext cx="2677647" cy="2415600"/>
          </a:xfrm>
          <a:prstGeom prst="rect">
            <a:avLst/>
          </a:prstGeom>
        </p:spPr>
      </p:pic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5368593"/>
              </p:ext>
            </p:extLst>
          </p:nvPr>
        </p:nvGraphicFramePr>
        <p:xfrm>
          <a:off x="572667" y="1422881"/>
          <a:ext cx="3317424" cy="1508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29356"/>
                <a:gridCol w="829356"/>
                <a:gridCol w="829356"/>
                <a:gridCol w="829356"/>
              </a:tblGrid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TE [</a:t>
                      </a:r>
                      <a:r>
                        <a:rPr lang="en-US" sz="1200" dirty="0" err="1" smtClean="0"/>
                        <a:t>ms</a:t>
                      </a:r>
                      <a:r>
                        <a:rPr lang="en-US" sz="1200" dirty="0" smtClean="0"/>
                        <a:t>]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 1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 2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nclusion</a:t>
                      </a:r>
                      <a:r>
                        <a:rPr lang="en-US" sz="1200" baseline="0" dirty="0" smtClean="0"/>
                        <a:t> 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5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48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647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276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12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049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624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574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241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841.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2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862.6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455.6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30.1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  <a:tr h="25146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40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70.9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72.33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2.77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49670" y="454357"/>
            <a:ext cx="77156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T2 </a:t>
            </a:r>
            <a:r>
              <a:rPr lang="en-US" sz="1600" b="1" dirty="0"/>
              <a:t>data for spherical inclusion phantom, acquired on: </a:t>
            </a:r>
            <a:r>
              <a:rPr lang="en-US" sz="1600" b="1" dirty="0" smtClean="0"/>
              <a:t>2019-04-18</a:t>
            </a:r>
            <a:endParaRPr lang="en-US" sz="1600" b="1" dirty="0"/>
          </a:p>
        </p:txBody>
      </p:sp>
      <p:sp>
        <p:nvSpPr>
          <p:cNvPr id="9" name="Rectangle 8"/>
          <p:cNvSpPr/>
          <p:nvPr/>
        </p:nvSpPr>
        <p:spPr>
          <a:xfrm>
            <a:off x="4307494" y="1418347"/>
            <a:ext cx="4023706" cy="1107996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modelfun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=@(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p,x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) p(1).*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exp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(-x./p(2)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%% for inclusion 1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error=@(p) sum((mag_TE1-modelfun(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p,TE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)).^2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P=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fminsearch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(error,[1 1]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M0_1=P(1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T2_1=P(2);</a:t>
            </a:r>
            <a:endParaRPr lang="en-US" sz="1100" dirty="0">
              <a:solidFill>
                <a:srgbClr val="000000"/>
              </a:solidFill>
              <a:latin typeface="Courier New" panose="02070309020205020404" pitchFamily="49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246537" y="1133671"/>
            <a:ext cx="20651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2) </a:t>
            </a:r>
            <a:r>
              <a:rPr lang="en-US" sz="1400" dirty="0" err="1" smtClean="0"/>
              <a:t>Matlab</a:t>
            </a:r>
            <a:r>
              <a:rPr lang="en-US" sz="1400" dirty="0" smtClean="0"/>
              <a:t> </a:t>
            </a:r>
            <a:r>
              <a:rPr lang="en-US" sz="1400" dirty="0"/>
              <a:t>code for fittin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90310" y="1133671"/>
            <a:ext cx="1591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1) Magnitude </a:t>
            </a:r>
            <a:r>
              <a:rPr lang="en-US" sz="1400" dirty="0"/>
              <a:t>dat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90310" y="3345965"/>
            <a:ext cx="1985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3) Results and T2 values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6619634" y="4045691"/>
            <a:ext cx="1502014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T2 for inclusion 3=45.34ms</a:t>
            </a:r>
            <a:endParaRPr lang="en-US" sz="1050" b="1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153" y="3636750"/>
            <a:ext cx="2677647" cy="2415600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62646" y="3643885"/>
            <a:ext cx="2677647" cy="24156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1109970" y="4043406"/>
            <a:ext cx="1502014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T2 for inclusion 1=99.85ms</a:t>
            </a:r>
            <a:endParaRPr lang="en-US" sz="105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890091" y="4045500"/>
            <a:ext cx="1502014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T2 for inclusion 2=59.59ms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36212472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그림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1474" y="4174850"/>
            <a:ext cx="2661685" cy="240120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782" y="4174850"/>
            <a:ext cx="2661685" cy="2401200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66128" y="4177046"/>
            <a:ext cx="2661685" cy="2401200"/>
          </a:xfrm>
          <a:prstGeom prst="rect">
            <a:avLst/>
          </a:prstGeom>
        </p:spPr>
      </p:pic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5769705"/>
              </p:ext>
            </p:extLst>
          </p:nvPr>
        </p:nvGraphicFramePr>
        <p:xfrm>
          <a:off x="572667" y="1111318"/>
          <a:ext cx="2990340" cy="26746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47585"/>
                <a:gridCol w="747585"/>
                <a:gridCol w="747585"/>
                <a:gridCol w="747585"/>
              </a:tblGrid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TE [</a:t>
                      </a:r>
                      <a:r>
                        <a:rPr lang="en-US" sz="900" dirty="0" err="1" smtClean="0"/>
                        <a:t>ms</a:t>
                      </a:r>
                      <a:r>
                        <a:rPr lang="en-US" sz="900" dirty="0" smtClean="0"/>
                        <a:t>]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Inclusion 1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Inclusion 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Inclusion</a:t>
                      </a:r>
                      <a:r>
                        <a:rPr lang="en-US" sz="900" baseline="0" dirty="0" smtClean="0"/>
                        <a:t> 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876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3018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678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726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769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386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61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565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158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469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345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924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34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146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714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3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23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98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538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3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211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81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37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4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998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66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23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4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915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548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12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5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803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39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995.8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57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729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290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914.8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  <a:tr h="138465"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60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692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1230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/>
                        <a:t>858.1</a:t>
                      </a:r>
                      <a:endParaRPr lang="en-US" sz="900" dirty="0"/>
                    </a:p>
                  </a:txBody>
                  <a:tcPr marL="68580" marR="68580" marT="34290" marB="34290"/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49670" y="454357"/>
            <a:ext cx="77156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T2* </a:t>
            </a:r>
            <a:r>
              <a:rPr lang="en-US" sz="1600" b="1" dirty="0"/>
              <a:t>data for spherical inclusion phantom, acquired on: </a:t>
            </a:r>
            <a:r>
              <a:rPr lang="en-US" sz="1600" b="1" dirty="0" smtClean="0"/>
              <a:t>2019-04-18</a:t>
            </a:r>
            <a:endParaRPr lang="en-US" sz="1600" b="1" dirty="0"/>
          </a:p>
        </p:txBody>
      </p:sp>
      <p:sp>
        <p:nvSpPr>
          <p:cNvPr id="9" name="Rectangle 8"/>
          <p:cNvSpPr/>
          <p:nvPr/>
        </p:nvSpPr>
        <p:spPr>
          <a:xfrm>
            <a:off x="4307494" y="1418347"/>
            <a:ext cx="4023706" cy="1107996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modelfun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=@(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p,x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) p(1).*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exp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(-x./p(2)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%% for inclusion 1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error=@(p) sum((mag_TE1-modelfun(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p,TE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)).^2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P=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fminsearch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(error,[1 1]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M0_1=P(1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T2star_1=P(2);</a:t>
            </a:r>
            <a:endParaRPr lang="en-US" sz="1100" dirty="0">
              <a:solidFill>
                <a:srgbClr val="000000"/>
              </a:solidFill>
              <a:latin typeface="Courier New" panose="02070309020205020404" pitchFamily="49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246537" y="1133671"/>
            <a:ext cx="20651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2) </a:t>
            </a:r>
            <a:r>
              <a:rPr lang="en-US" sz="1400" dirty="0" err="1" smtClean="0"/>
              <a:t>Matlab</a:t>
            </a:r>
            <a:r>
              <a:rPr lang="en-US" sz="1400" dirty="0" smtClean="0"/>
              <a:t> </a:t>
            </a:r>
            <a:r>
              <a:rPr lang="en-US" sz="1400" dirty="0"/>
              <a:t>code for fittin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90310" y="822108"/>
            <a:ext cx="1591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1) Magnitude </a:t>
            </a:r>
            <a:r>
              <a:rPr lang="en-US" sz="1400" dirty="0"/>
              <a:t>dat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90310" y="3871465"/>
            <a:ext cx="8063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3) Results and T2* values (</a:t>
            </a:r>
            <a:r>
              <a:rPr lang="en-US" sz="1400" i="1" dirty="0" smtClean="0"/>
              <a:t>Note:</a:t>
            </a:r>
            <a:r>
              <a:rPr lang="en-US" sz="1400" dirty="0" smtClean="0"/>
              <a:t> This was a two-parameter fitting; linear portion does not mean overfitting.)</a:t>
            </a:r>
            <a:endParaRPr 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987989" y="4570999"/>
            <a:ext cx="1747273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 T2star for inclusion 1=97.87ms</a:t>
            </a:r>
            <a:endParaRPr lang="en-US" sz="105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3760297" y="4570998"/>
            <a:ext cx="1716817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T2star for inclusion 2=58.85ms</a:t>
            </a:r>
            <a:endParaRPr lang="en-US" sz="105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6499126" y="4570997"/>
            <a:ext cx="1716817" cy="161583"/>
          </a:xfrm>
          <a:prstGeom prst="rect">
            <a:avLst/>
          </a:prstGeom>
          <a:solidFill>
            <a:schemeClr val="bg2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50" b="1" dirty="0" smtClean="0"/>
              <a:t>T2star for inclusion 3=45.93ms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2652690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</TotalTime>
  <Words>378</Words>
  <Application>Microsoft Office PowerPoint</Application>
  <PresentationFormat>On-screen Show (4:3)</PresentationFormat>
  <Paragraphs>145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Author</cp:lastModifiedBy>
  <cp:revision>17</cp:revision>
  <dcterms:created xsi:type="dcterms:W3CDTF">2019-05-26T21:24:55Z</dcterms:created>
  <dcterms:modified xsi:type="dcterms:W3CDTF">2019-06-08T06:22:31Z</dcterms:modified>
</cp:coreProperties>
</file>